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5B5ED3-6CF9-4835-BB06-2B9ECA320C4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79F6E8-F17E-4A3E-8FCB-A6E09CFA23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3B5557-C497-4E11-BFA2-C6053FAC1EA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ED67F9-468B-454F-99DE-F0FF6F86BAB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1C54E5-C106-43E3-BA16-83CAB482F1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09BAC3-B341-4D6F-995D-6CB991CEDC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D4568B-C403-46EA-A14D-C25C10E11E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13C95F-FAA1-4CE8-9C32-7BB2E580B42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2DE261-52A9-40A4-99AD-EF3B9EF858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EDC2DD-5EAB-4167-96F9-62141D86DB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987DE5-7CAD-4386-8D91-57EC9CB11D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D05037-471C-4278-B94B-DAABDBCB03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50F8E7D-2900-4925-A32D-982B4B686AC7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64"/>
          <p:cNvGrpSpPr/>
          <p:nvPr/>
        </p:nvGrpSpPr>
        <p:grpSpPr>
          <a:xfrm>
            <a:off x="458640" y="2066760"/>
            <a:ext cx="5977080" cy="1926360"/>
            <a:chOff x="458640" y="2066760"/>
            <a:chExt cx="5977080" cy="1926360"/>
          </a:xfrm>
        </p:grpSpPr>
        <p:sp>
          <p:nvSpPr>
            <p:cNvPr id="42" name="TextBox 2"/>
            <p:cNvSpPr/>
            <p:nvPr/>
          </p:nvSpPr>
          <p:spPr>
            <a:xfrm>
              <a:off x="584280" y="2529360"/>
              <a:ext cx="5851440" cy="1310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2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TGCCCAGCAACACCTAATCTGGCTGCGGCAGGTGCTCAGGAAACGCTAGTCAAGGAGAAAGGCACTAGCTTTCGCTCTGC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CCCTGCCCCA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CCCA</a:t>
              </a:r>
              <a:r>
                <a:rPr b="0" i="1" lang="en-US" sz="8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GGGGCGGG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C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GTAGAGGCGCCTATAAGGGAAGTTGTTCAGTCAACTCGGAAAAAGGGTAACAACCCGGAAAGTAGACTCACCGTCTTGGTCTAGAGACTGACCCCTGCACAGACAGACCCCTTCCCCTCTCTGCGAAAG</a:t>
              </a: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GACCAAGCCCC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GAAGTCACTCCATCTCCTACGGCTCGCAATTTCCAGAGGCCCCCTGGCACCTTCCAGCCTG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43" name="直接箭头连接符 3"/>
            <p:cNvCxnSpPr/>
            <p:nvPr/>
          </p:nvCxnSpPr>
          <p:spPr>
            <a:xfrm>
              <a:off x="1791000" y="3147120"/>
              <a:ext cx="648360" cy="108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44" name="TextBox 4"/>
            <p:cNvSpPr/>
            <p:nvPr/>
          </p:nvSpPr>
          <p:spPr>
            <a:xfrm>
              <a:off x="1877040" y="3111840"/>
              <a:ext cx="4716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p1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直接连接符 5"/>
            <p:cNvSpPr/>
            <p:nvPr/>
          </p:nvSpPr>
          <p:spPr>
            <a:xfrm flipH="1">
              <a:off x="809640" y="2403360"/>
              <a:ext cx="2727000" cy="126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直接连接符 6"/>
            <p:cNvSpPr/>
            <p:nvPr/>
          </p:nvSpPr>
          <p:spPr>
            <a:xfrm>
              <a:off x="5350680" y="2394720"/>
              <a:ext cx="925920" cy="149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Box 7"/>
            <p:cNvSpPr/>
            <p:nvPr/>
          </p:nvSpPr>
          <p:spPr>
            <a:xfrm>
              <a:off x="528120" y="2462040"/>
              <a:ext cx="424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10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Box 8"/>
            <p:cNvSpPr/>
            <p:nvPr/>
          </p:nvSpPr>
          <p:spPr>
            <a:xfrm>
              <a:off x="4473720" y="3373560"/>
              <a:ext cx="484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21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49" name="直接箭头连接符 9"/>
            <p:cNvCxnSpPr/>
            <p:nvPr/>
          </p:nvCxnSpPr>
          <p:spPr>
            <a:xfrm flipH="1">
              <a:off x="1762560" y="2898720"/>
              <a:ext cx="1080" cy="11448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50" name="直接箭头连接符 10"/>
            <p:cNvCxnSpPr/>
            <p:nvPr/>
          </p:nvCxnSpPr>
          <p:spPr>
            <a:xfrm flipH="1">
              <a:off x="677880" y="2596680"/>
              <a:ext cx="1080" cy="11448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51" name="TextBox 11"/>
            <p:cNvSpPr/>
            <p:nvPr/>
          </p:nvSpPr>
          <p:spPr>
            <a:xfrm>
              <a:off x="1583640" y="2722680"/>
              <a:ext cx="34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2" name="组合 61"/>
            <p:cNvGrpSpPr/>
            <p:nvPr/>
          </p:nvGrpSpPr>
          <p:grpSpPr>
            <a:xfrm>
              <a:off x="458640" y="2066760"/>
              <a:ext cx="5708160" cy="418680"/>
              <a:chOff x="458640" y="2066760"/>
              <a:chExt cx="5708160" cy="418680"/>
            </a:xfrm>
          </p:grpSpPr>
          <p:grpSp>
            <p:nvGrpSpPr>
              <p:cNvPr id="53" name="组合 30"/>
              <p:cNvGrpSpPr/>
              <p:nvPr/>
            </p:nvGrpSpPr>
            <p:grpSpPr>
              <a:xfrm>
                <a:off x="867600" y="2066760"/>
                <a:ext cx="4772160" cy="342720"/>
                <a:chOff x="867600" y="2066760"/>
                <a:chExt cx="4772160" cy="342720"/>
              </a:xfrm>
            </p:grpSpPr>
            <p:grpSp>
              <p:nvGrpSpPr>
                <p:cNvPr id="54" name="组合 6"/>
                <p:cNvGrpSpPr/>
                <p:nvPr/>
              </p:nvGrpSpPr>
              <p:grpSpPr>
                <a:xfrm>
                  <a:off x="867600" y="2315880"/>
                  <a:ext cx="4586040" cy="93600"/>
                  <a:chOff x="867600" y="2315880"/>
                  <a:chExt cx="4586040" cy="93600"/>
                </a:xfrm>
              </p:grpSpPr>
              <p:sp>
                <p:nvSpPr>
                  <p:cNvPr id="55" name="矩形 2"/>
                  <p:cNvSpPr/>
                  <p:nvPr/>
                </p:nvSpPr>
                <p:spPr>
                  <a:xfrm>
                    <a:off x="867600" y="2315880"/>
                    <a:ext cx="3370320" cy="93600"/>
                  </a:xfrm>
                  <a:prstGeom prst="rect">
                    <a:avLst/>
                  </a:prstGeom>
                  <a:solidFill>
                    <a:srgbClr val="ffffff"/>
                  </a:solidFill>
                  <a:ln w="255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6" name="矩形 3"/>
                  <p:cNvSpPr/>
                  <p:nvPr/>
                </p:nvSpPr>
                <p:spPr>
                  <a:xfrm>
                    <a:off x="4213440" y="2315880"/>
                    <a:ext cx="1124280" cy="93600"/>
                  </a:xfrm>
                  <a:prstGeom prst="rect">
                    <a:avLst/>
                  </a:prstGeom>
                  <a:solidFill>
                    <a:srgbClr val="000000"/>
                  </a:solidFill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57" name="直接连接符 5"/>
                  <p:cNvSpPr/>
                  <p:nvPr/>
                </p:nvSpPr>
                <p:spPr>
                  <a:xfrm>
                    <a:off x="5338080" y="2362680"/>
                    <a:ext cx="115560" cy="720"/>
                  </a:xfrm>
                  <a:prstGeom prst="line">
                    <a:avLst/>
                  </a:prstGeom>
                  <a:ln w="38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58" name="TextBox 21"/>
                <p:cNvSpPr/>
                <p:nvPr/>
              </p:nvSpPr>
              <p:spPr>
                <a:xfrm>
                  <a:off x="3375000" y="2066760"/>
                  <a:ext cx="4852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-10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9" name="TextBox 24"/>
                <p:cNvSpPr/>
                <p:nvPr/>
              </p:nvSpPr>
              <p:spPr>
                <a:xfrm>
                  <a:off x="5081400" y="2066760"/>
                  <a:ext cx="5583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+210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0" name="直接连接符 23"/>
                <p:cNvSpPr/>
                <p:nvPr/>
              </p:nvSpPr>
              <p:spPr>
                <a:xfrm flipH="1">
                  <a:off x="3535920" y="2222280"/>
                  <a:ext cx="720" cy="9360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1" name="直接连接符 24"/>
                <p:cNvSpPr/>
                <p:nvPr/>
              </p:nvSpPr>
              <p:spPr>
                <a:xfrm flipH="1">
                  <a:off x="5330880" y="2221920"/>
                  <a:ext cx="720" cy="9360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2" name="直接连接符 25"/>
                <p:cNvSpPr/>
                <p:nvPr/>
              </p:nvSpPr>
              <p:spPr>
                <a:xfrm flipH="1">
                  <a:off x="4214880" y="2221920"/>
                  <a:ext cx="720" cy="93600"/>
                </a:xfrm>
                <a:prstGeom prst="line">
                  <a:avLst/>
                </a:prstGeom>
                <a:ln w="255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3" name="TextBox 26"/>
                <p:cNvSpPr/>
                <p:nvPr/>
              </p:nvSpPr>
              <p:spPr>
                <a:xfrm>
                  <a:off x="4045320" y="2066760"/>
                  <a:ext cx="4078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+1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64" name="TextBox 17"/>
              <p:cNvSpPr/>
              <p:nvPr/>
            </p:nvSpPr>
            <p:spPr>
              <a:xfrm>
                <a:off x="458640" y="2240280"/>
                <a:ext cx="545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5’ · · ·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TextBox 18"/>
              <p:cNvSpPr/>
              <p:nvPr/>
            </p:nvSpPr>
            <p:spPr>
              <a:xfrm>
                <a:off x="5615280" y="2225880"/>
                <a:ext cx="551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· · ·3’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" name="椭圆 19"/>
              <p:cNvSpPr/>
              <p:nvPr/>
            </p:nvSpPr>
            <p:spPr>
              <a:xfrm>
                <a:off x="4170960" y="2257200"/>
                <a:ext cx="94320" cy="228240"/>
              </a:xfrm>
              <a:prstGeom prst="ellipse">
                <a:avLst/>
              </a:prstGeom>
              <a:solidFill>
                <a:srgbClr val="000000"/>
              </a:solidFill>
              <a:ln w="3240">
                <a:solidFill>
                  <a:srgbClr val="385d8a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7" name="椭圆 13"/>
            <p:cNvSpPr/>
            <p:nvPr/>
          </p:nvSpPr>
          <p:spPr>
            <a:xfrm>
              <a:off x="2772360" y="3743640"/>
              <a:ext cx="94320" cy="22824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385d8a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TextBox 14"/>
            <p:cNvSpPr/>
            <p:nvPr/>
          </p:nvSpPr>
          <p:spPr>
            <a:xfrm>
              <a:off x="2829240" y="3746880"/>
              <a:ext cx="2595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utative Sp1 binding site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69" name="直接箭头连接符 15"/>
            <p:cNvCxnSpPr/>
            <p:nvPr/>
          </p:nvCxnSpPr>
          <p:spPr>
            <a:xfrm flipH="1">
              <a:off x="4676760" y="3529080"/>
              <a:ext cx="1080" cy="11448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</p:grpSp>
      <p:sp>
        <p:nvSpPr>
          <p:cNvPr id="70" name="TextBox 30"/>
          <p:cNvSpPr/>
          <p:nvPr/>
        </p:nvSpPr>
        <p:spPr>
          <a:xfrm>
            <a:off x="458640" y="1231920"/>
            <a:ext cx="990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Fig. S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矩形 31"/>
          <p:cNvSpPr/>
          <p:nvPr/>
        </p:nvSpPr>
        <p:spPr>
          <a:xfrm>
            <a:off x="157320" y="4103640"/>
            <a:ext cx="67006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.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chematic representation of the Rip3 promoter. Underlined region indicated Sp1 binding sites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19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0-24T08:23:54Z</dcterms:created>
  <dc:creator>lj</dc:creator>
  <dc:description/>
  <dc:language>en-US</dc:language>
  <cp:lastModifiedBy>vidya.p</cp:lastModifiedBy>
  <cp:lastPrinted>2016-03-10T05:57:39Z</cp:lastPrinted>
  <dcterms:modified xsi:type="dcterms:W3CDTF">2017-09-28T04:24:13Z</dcterms:modified>
  <cp:revision>423</cp:revision>
  <dc:subject/>
  <dc:title>幻灯片 1</dc:title>
</cp:coreProperties>
</file>